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7" userDrawn="1">
          <p15:clr>
            <a:srgbClr val="A4A3A4"/>
          </p15:clr>
        </p15:guide>
        <p15:guide id="2" pos="37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EBDD"/>
    <a:srgbClr val="C79DC7"/>
    <a:srgbClr val="FFFFFF"/>
    <a:srgbClr val="C8E8F8"/>
    <a:srgbClr val="0000FF"/>
    <a:srgbClr val="0001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66" autoAdjust="0"/>
    <p:restoredTop sz="94645" autoAdjust="0"/>
  </p:normalViewPr>
  <p:slideViewPr>
    <p:cSldViewPr snapToGrid="0" showGuides="1">
      <p:cViewPr>
        <p:scale>
          <a:sx n="50" d="100"/>
          <a:sy n="50" d="100"/>
        </p:scale>
        <p:origin x="2601" y="282"/>
      </p:cViewPr>
      <p:guideLst>
        <p:guide orient="horz" pos="3687"/>
        <p:guide pos="37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0992" tIns="45496" rIns="90992" bIns="45496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0992" tIns="45496" rIns="90992" bIns="45496" rtlCol="0"/>
          <a:lstStyle>
            <a:lvl1pPr algn="r">
              <a:defRPr sz="1200"/>
            </a:lvl1pPr>
          </a:lstStyle>
          <a:p>
            <a:fld id="{848CC3A0-17F8-4A76-9F29-DCDBB208B562}" type="datetimeFigureOut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9838"/>
            <a:ext cx="2317750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992" tIns="45496" rIns="90992" bIns="45496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0992" tIns="45496" rIns="90992" bIns="45496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8055"/>
          </a:xfrm>
          <a:prstGeom prst="rect">
            <a:avLst/>
          </a:prstGeom>
        </p:spPr>
        <p:txBody>
          <a:bodyPr vert="horz" lIns="90992" tIns="45496" rIns="90992" bIns="45496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8055"/>
          </a:xfrm>
          <a:prstGeom prst="rect">
            <a:avLst/>
          </a:prstGeom>
        </p:spPr>
        <p:txBody>
          <a:bodyPr vert="horz" lIns="90992" tIns="45496" rIns="90992" bIns="45496" rtlCol="0" anchor="b"/>
          <a:lstStyle>
            <a:lvl1pPr algn="r">
              <a:defRPr sz="1200"/>
            </a:lvl1pPr>
          </a:lstStyle>
          <a:p>
            <a:fld id="{748AF32C-8723-4DC1-8835-566872E13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66901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8AF32C-8723-4DC1-8835-566872E13158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361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89B4-DA76-40FE-9079-DB7312C44F47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200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9D438-8A34-48F6-950C-B2ECFDF350E7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327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71C8C-B63A-4F4B-A58D-A84777D100D7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5276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E3417-C847-4E7A-A095-C875DE1268C0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404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7CE9F-CB6A-43F9-A1BC-E87B4219CA87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9053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DE81C-FE1F-42D4-AAD1-2AD0FA6DB736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1352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47D31-2791-4D9B-941F-5415DC3C0A8A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6159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F97D3-964F-4DB2-81F1-51A5E370BD83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2798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D8971-F7CE-4E01-9859-F6000BE6AE0D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308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22479-0883-4C4C-9E03-76EE3107B3FC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8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BAB17-E6A1-40DB-A344-4F48715AF22C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7212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7DA74-D91C-426C-B41F-8E6A2A9EAAAC}" type="datetime1">
              <a:rPr lang="zh-CN" altLang="en-US" smtClean="0"/>
              <a:pPr/>
              <a:t>2025/2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60D7F-3AE9-482E-BD51-1BC3D4AC5C2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4143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AA7D4C1-50FD-9868-192D-38E589777269}"/>
              </a:ext>
            </a:extLst>
          </p:cNvPr>
          <p:cNvSpPr txBox="1"/>
          <p:nvPr/>
        </p:nvSpPr>
        <p:spPr>
          <a:xfrm>
            <a:off x="100913" y="89248"/>
            <a:ext cx="6656173" cy="92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deo legends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deo S1. The processes of parenchymal microglia make nonpolar movements.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lapse video of a live brain section from a naive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x3cr1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FP/+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orter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use, taken by a time-lapse two-photon microscopy from parenchymal area. Red, AQP4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rames were collected at the frequency of every 4 min.</a:t>
            </a:r>
          </a:p>
          <a:p>
            <a:pPr algn="just">
              <a:lnSpc>
                <a:spcPct val="200000"/>
              </a:lnSpc>
            </a:pPr>
            <a:endParaRPr lang="en-US" altLang="zh-CN" sz="1200" b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deo S2. A panoramic view of the movements of the processes of paraventricular phagocytes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lapse video of a live brain section from a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x3cr1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FP/+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orter mouse with the ependymal wall labeled by AQP4 (red)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ree-dimensional rendering of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movements of the processes of paraventricular phagocyte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Frames were collected at the frequency of every 4 min.</a:t>
            </a:r>
            <a:endParaRPr lang="zh-CN" altLang="zh-CN" sz="105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endParaRPr lang="en-US" altLang="zh-CN" sz="1200" b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deo S3. The processes of paraventricular phagocytes make </a:t>
            </a: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polar movements preferentially towards the ventricle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lapse video of a live brain section from a naive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x3cr1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FP/+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orter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use, taken by a time-lapse two-photon microscopy from paraventricular area. Ependymal cells labeled with AQP4 (red)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rames were collected at the frequency of every 4 min.</a:t>
            </a:r>
          </a:p>
          <a:p>
            <a:pPr algn="just">
              <a:lnSpc>
                <a:spcPct val="200000"/>
              </a:lnSpc>
            </a:pPr>
            <a:endParaRPr lang="en-US" altLang="zh-CN" sz="12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deo S4-S5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aventricular phagocytes would undergo transe</a:t>
            </a:r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ndymal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gration either from the basolateral side of the ventricular wall to the apical side (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deo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) or vice versa (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deo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5).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lapse video of a live brain section from a naive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x3cr1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FP/+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orter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use, taken by a time-lapse two-photon microscopy from paraventricular area. Ependymal cells labeled with AQP4 (red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rrow,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starting position of the paraventricular phagocyte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200000"/>
              </a:lnSpc>
            </a:pPr>
            <a:endParaRPr lang="en-US" altLang="zh-CN" sz="12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ideo S6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ome phagocytes would migrate along the ventricular wall at the apical CSF-containing side.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lapse video of a live brain section from a naive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x3cr1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FP/+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orter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use, taken by a time-lapse two-photon microscopy from paraventricular area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rames were collected at the frequency of every 4 min.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rrow,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starting position of the phagocyte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52046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53</TotalTime>
  <Words>320</Words>
  <Application>Microsoft Office PowerPoint</Application>
  <PresentationFormat>A4 纸张(210x297 毫米)</PresentationFormat>
  <Paragraphs>1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Z7040</dc:creator>
  <cp:lastModifiedBy>Jian He</cp:lastModifiedBy>
  <cp:revision>424</cp:revision>
  <cp:lastPrinted>2023-07-14T06:46:28Z</cp:lastPrinted>
  <dcterms:created xsi:type="dcterms:W3CDTF">2022-03-10T08:46:06Z</dcterms:created>
  <dcterms:modified xsi:type="dcterms:W3CDTF">2025-02-23T13:51:05Z</dcterms:modified>
</cp:coreProperties>
</file>